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2213A2-6EDD-44E6-91E5-C84C7B3EE55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64EF96-D50D-4E3D-AD0B-60AF8E862F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1A3390-2D63-4D91-884A-B8A3E8EE6CF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DE8BF9-C738-4B10-A712-8C9573E8AB1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BB0103-F8FC-4B23-BE08-DA818134331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BFF157-517C-4BAA-BEA6-B36BD79845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102EC9-3A9A-49A9-9754-013C1D8055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49A244-AC5A-4416-B644-D610679780C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4B5D64-058F-45FC-ACC3-C4EE4A3DF1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4EF25C-47DE-49DE-8497-36E296D758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7360A6-3F1D-4FA2-AE1F-FC8BAA05DC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51F1FD-95EE-42C9-888F-E1DAACD524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0763A0-E5AB-41D0-B4CE-31F38E40EC4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11"/>
          <p:cNvSpPr/>
          <p:nvPr/>
        </p:nvSpPr>
        <p:spPr>
          <a:xfrm>
            <a:off x="826920" y="415800"/>
            <a:ext cx="4537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Table S1  Patient profile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116000" y="1052640"/>
          <a:ext cx="7561440" cy="4751280"/>
        </p:xfrm>
        <a:graphic>
          <a:graphicData uri="http://schemas.openxmlformats.org/drawingml/2006/table">
            <a:tbl>
              <a:tblPr/>
              <a:tblGrid>
                <a:gridCol w="4896000"/>
                <a:gridCol w="1454040"/>
                <a:gridCol w="1211400"/>
              </a:tblGrid>
              <a:tr h="30780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960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468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ja-JP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　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Mean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  </a:t>
                      </a: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(95%CI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761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Age (years old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65.2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(63.8-66.5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7468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Height (m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1.5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(1.50-1.52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1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Body weight (kg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53.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(51.5-55.2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BMI (kg/m</a:t>
                      </a:r>
                      <a:r>
                        <a:rPr b="1" lang="en-US" sz="1600" spc="-1" strike="noStrike" baseline="30000">
                          <a:solidFill>
                            <a:srgbClr val="000000"/>
                          </a:solidFill>
                          <a:latin typeface="ＭＳ Ｐゴシック"/>
                        </a:rPr>
                        <a:t>2</a:t>
                      </a: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23.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(22.6-24.0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468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Age at menarche (years old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14.9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(14.7-15.2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1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Age at menopause (years old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49.7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(48.8-50.5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1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Duration after menopause (years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15.5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(13.9-16.7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468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Percent of body fat (%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37.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(36.8-38.3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1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Lean body mass (kg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33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(32.2-33.8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468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Fat mass (kg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20.4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(19.4-21.5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1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Lumbar BMD (%YAM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81.6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(78.8-84.4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48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Lumbar BLR (%YAM/year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0.41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(0.25-0.57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468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Femoral BMD  (%YAM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80.8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(78.4-83.2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6120">
                <a:tc>
                  <a:txBody>
                    <a:bodyPr lIns="9360" rIns="9360" tIns="936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Femoral BLR (%YAM/year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0.50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600" spc="-1" strike="noStrike">
                          <a:solidFill>
                            <a:srgbClr val="000000"/>
                          </a:solidFill>
                          <a:latin typeface="ＭＳ Ｐゴシック"/>
                        </a:rPr>
                        <a:t>(0.35-0.65)</a:t>
                      </a:r>
                      <a:endParaRPr b="0" lang="en-US" sz="1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2-12T05:26:24Z</dcterms:created>
  <dc:creator>山本　威久</dc:creator>
  <dc:description/>
  <dc:language>en-US</dc:language>
  <cp:lastModifiedBy>山本威久</cp:lastModifiedBy>
  <dcterms:modified xsi:type="dcterms:W3CDTF">2017-11-03T10:32:21Z</dcterms:modified>
  <cp:revision>60</cp:revision>
  <dc:subject/>
  <dc:title>スライド 1</dc:title>
</cp:coreProperties>
</file>